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vml" ContentType="application/vnd.openxmlformats-officedocument.vmlDrawing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embeddings/oleObject1.bin" ContentType="application/vnd.openxmlformats-officedocument.oleObject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 varScale="1">
        <p:scale>
          <a:sx n="56" d="100"/>
          <a:sy n="56" d="100"/>
        </p:scale>
        <p:origin x="-2400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1May20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1May2015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1May2015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6Jun20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8716280153395"/>
          <c:y val="0.0733196108864745"/>
          <c:w val="0.478410097150975"/>
          <c:h val="0.686924373330491"/>
        </c:manualLayout>
      </c:layout>
      <c:barChart>
        <c:barDir val="col"/>
        <c:grouping val="clustered"/>
        <c:varyColors val="0"/>
        <c:ser>
          <c:idx val="0"/>
          <c:order val="0"/>
          <c:tx>
            <c:v>LI</c:v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Charts_26Jun2015!$S$18:$S$20</c:f>
                <c:numCache>
                  <c:formatCode>General</c:formatCode>
                  <c:ptCount val="3"/>
                  <c:pt idx="0">
                    <c:v>0.0700045859291521</c:v>
                  </c:pt>
                  <c:pt idx="1">
                    <c:v>0.0659941498693045</c:v>
                  </c:pt>
                  <c:pt idx="2">
                    <c:v>0.04673941466518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Charts_26Jun2015!$O$18:$O$20</c:f>
              <c:strCache>
                <c:ptCount val="3"/>
                <c:pt idx="0">
                  <c:v>MB419B</c:v>
                </c:pt>
                <c:pt idx="1">
                  <c:v>MB009B</c:v>
                </c:pt>
                <c:pt idx="2">
                  <c:v>MB131B</c:v>
                </c:pt>
              </c:strCache>
            </c:strRef>
          </c:cat>
          <c:val>
            <c:numRef>
              <c:f>NewCharts_26Jun2015!$P$18:$P$20</c:f>
              <c:numCache>
                <c:formatCode>General</c:formatCode>
                <c:ptCount val="3"/>
                <c:pt idx="0">
                  <c:v>0.0929782575757575</c:v>
                </c:pt>
                <c:pt idx="1">
                  <c:v>0.236254833333333</c:v>
                </c:pt>
                <c:pt idx="2">
                  <c:v>0.0991860606060606</c:v>
                </c:pt>
              </c:numCache>
            </c:numRef>
          </c:val>
        </c:ser>
        <c:ser>
          <c:idx val="1"/>
          <c:order val="1"/>
          <c:tx>
            <c:v>MI</c:v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NewCharts_26Jun2015!$T$18:$T$20</c:f>
                <c:numCache>
                  <c:formatCode>General</c:formatCode>
                  <c:ptCount val="3"/>
                  <c:pt idx="0">
                    <c:v>0.0956055495106547</c:v>
                  </c:pt>
                  <c:pt idx="1">
                    <c:v>0.0822233837945492</c:v>
                  </c:pt>
                  <c:pt idx="2">
                    <c:v>0.0461054070607285</c:v>
                  </c:pt>
                </c:numCache>
              </c:numRef>
            </c:minus>
          </c:errBars>
          <c:cat>
            <c:strRef>
              <c:f>NewCharts_26Jun2015!$O$18:$O$20</c:f>
              <c:strCache>
                <c:ptCount val="3"/>
                <c:pt idx="0">
                  <c:v>MB419B</c:v>
                </c:pt>
                <c:pt idx="1">
                  <c:v>MB009B</c:v>
                </c:pt>
                <c:pt idx="2">
                  <c:v>MB131B</c:v>
                </c:pt>
              </c:strCache>
            </c:strRef>
          </c:cat>
          <c:val>
            <c:numRef>
              <c:f>NewCharts_26Jun2015!$Q$18:$Q$20</c:f>
              <c:numCache>
                <c:formatCode>General</c:formatCode>
                <c:ptCount val="3"/>
                <c:pt idx="0">
                  <c:v>-0.178811666666667</c:v>
                </c:pt>
                <c:pt idx="1">
                  <c:v>-0.185971333333333</c:v>
                </c:pt>
                <c:pt idx="2">
                  <c:v>-0.09987545454545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6839544"/>
        <c:axId val="-2116836536"/>
      </c:barChart>
      <c:catAx>
        <c:axId val="-2116839544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16836536"/>
        <c:crosses val="autoZero"/>
        <c:auto val="1"/>
        <c:lblAlgn val="ctr"/>
        <c:lblOffset val="100"/>
        <c:noMultiLvlLbl val="0"/>
      </c:catAx>
      <c:valAx>
        <c:axId val="-2116836536"/>
        <c:scaling>
          <c:orientation val="minMax"/>
          <c:max val="0.6"/>
          <c:min val="-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683954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66503398675157"/>
          <c:y val="0.0733196108864745"/>
          <c:w val="0.474905121039929"/>
          <c:h val="0.6869243733304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ewSecondaryCharts_22May15!$P$2</c:f>
              <c:strCache>
                <c:ptCount val="1"/>
                <c:pt idx="0">
                  <c:v>LI</c:v>
                </c:pt>
              </c:strCache>
            </c:strRef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SecondaryCharts_22May15!$S$3:$S$5</c:f>
                <c:numCache>
                  <c:formatCode>General</c:formatCode>
                  <c:ptCount val="3"/>
                  <c:pt idx="0">
                    <c:v>0.0383146569870722</c:v>
                  </c:pt>
                  <c:pt idx="1">
                    <c:v>0.0455503515705514</c:v>
                  </c:pt>
                  <c:pt idx="2">
                    <c:v>0.2101614870697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econdaryCharts_22May15!$O$3:$O$5</c:f>
              <c:strCache>
                <c:ptCount val="3"/>
                <c:pt idx="0">
                  <c:v>MB419B</c:v>
                </c:pt>
                <c:pt idx="1">
                  <c:v>MB607B</c:v>
                </c:pt>
                <c:pt idx="2">
                  <c:v>MB131B</c:v>
                </c:pt>
              </c:strCache>
            </c:strRef>
          </c:cat>
          <c:val>
            <c:numRef>
              <c:f>NewSecondaryCharts_22May15!$P$3:$P$5</c:f>
              <c:numCache>
                <c:formatCode>General</c:formatCode>
                <c:ptCount val="3"/>
                <c:pt idx="0">
                  <c:v>0.127717777777778</c:v>
                </c:pt>
                <c:pt idx="1">
                  <c:v>0.0285596825714286</c:v>
                </c:pt>
                <c:pt idx="2">
                  <c:v>0.224476</c:v>
                </c:pt>
              </c:numCache>
            </c:numRef>
          </c:val>
        </c:ser>
        <c:ser>
          <c:idx val="1"/>
          <c:order val="1"/>
          <c:tx>
            <c:strRef>
              <c:f>NewSecondaryCharts_22May15!$Q$2</c:f>
              <c:strCache>
                <c:ptCount val="1"/>
                <c:pt idx="0">
                  <c:v>MI</c:v>
                </c:pt>
              </c:strCache>
            </c:strRef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NewSecondaryCharts_22May15!$T$3:$T$5</c:f>
                <c:numCache>
                  <c:formatCode>General</c:formatCode>
                  <c:ptCount val="3"/>
                  <c:pt idx="0">
                    <c:v>0.0812043115189508</c:v>
                  </c:pt>
                  <c:pt idx="1">
                    <c:v>0.0934170671230094</c:v>
                  </c:pt>
                  <c:pt idx="2">
                    <c:v>0.0842838992648401</c:v>
                  </c:pt>
                </c:numCache>
              </c:numRef>
            </c:minus>
          </c:errBars>
          <c:cat>
            <c:strRef>
              <c:f>NewSecondaryCharts_22May15!$O$3:$O$5</c:f>
              <c:strCache>
                <c:ptCount val="3"/>
                <c:pt idx="0">
                  <c:v>MB419B</c:v>
                </c:pt>
                <c:pt idx="1">
                  <c:v>MB607B</c:v>
                </c:pt>
                <c:pt idx="2">
                  <c:v>MB131B</c:v>
                </c:pt>
              </c:strCache>
            </c:strRef>
          </c:cat>
          <c:val>
            <c:numRef>
              <c:f>NewSecondaryCharts_22May15!$Q$3:$Q$5</c:f>
              <c:numCache>
                <c:formatCode>General</c:formatCode>
                <c:ptCount val="3"/>
                <c:pt idx="0">
                  <c:v>-0.2548874075</c:v>
                </c:pt>
                <c:pt idx="1">
                  <c:v>-0.246754126952381</c:v>
                </c:pt>
                <c:pt idx="2">
                  <c:v>-0.3364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9450360"/>
        <c:axId val="-2119419144"/>
      </c:barChart>
      <c:catAx>
        <c:axId val="-2119450360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19419144"/>
        <c:crosses val="autoZero"/>
        <c:auto val="1"/>
        <c:lblAlgn val="ctr"/>
        <c:lblOffset val="100"/>
        <c:noMultiLvlLbl val="0"/>
      </c:catAx>
      <c:valAx>
        <c:axId val="-21194191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945036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LI</c:v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Charts_26Jun2015!$S$30:$S$33</c:f>
                <c:numCache>
                  <c:formatCode>General</c:formatCode>
                  <c:ptCount val="4"/>
                  <c:pt idx="0">
                    <c:v>0.0577820358551417</c:v>
                  </c:pt>
                  <c:pt idx="1">
                    <c:v>0.0613197755282914</c:v>
                  </c:pt>
                  <c:pt idx="2">
                    <c:v>0.0317877803399094</c:v>
                  </c:pt>
                  <c:pt idx="3">
                    <c:v>0.05830005173211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Charts_26Jun2015!$O$30:$O$33</c:f>
              <c:strCache>
                <c:ptCount val="4"/>
                <c:pt idx="0">
                  <c:v>MB010B</c:v>
                </c:pt>
                <c:pt idx="1">
                  <c:v>MB152B</c:v>
                </c:pt>
                <c:pt idx="2">
                  <c:v>MB364B</c:v>
                </c:pt>
                <c:pt idx="3">
                  <c:v>MB417B</c:v>
                </c:pt>
              </c:strCache>
            </c:strRef>
          </c:cat>
          <c:val>
            <c:numRef>
              <c:f>NewCharts_26Jun2015!$P$30:$P$33</c:f>
              <c:numCache>
                <c:formatCode>General</c:formatCode>
                <c:ptCount val="4"/>
                <c:pt idx="0">
                  <c:v>0.212228174603175</c:v>
                </c:pt>
                <c:pt idx="1">
                  <c:v>0.370140277777778</c:v>
                </c:pt>
                <c:pt idx="2">
                  <c:v>0.101931875</c:v>
                </c:pt>
                <c:pt idx="3">
                  <c:v>0.203761333333333</c:v>
                </c:pt>
              </c:numCache>
            </c:numRef>
          </c:val>
        </c:ser>
        <c:ser>
          <c:idx val="1"/>
          <c:order val="1"/>
          <c:tx>
            <c:v>MI</c:v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NewCharts_26Jun2015!$T$30:$T$33</c:f>
                <c:numCache>
                  <c:formatCode>General</c:formatCode>
                  <c:ptCount val="4"/>
                  <c:pt idx="0">
                    <c:v>0.0576895116993077</c:v>
                  </c:pt>
                  <c:pt idx="1">
                    <c:v>0.0616956752491556</c:v>
                  </c:pt>
                  <c:pt idx="2">
                    <c:v>0.0439871165884744</c:v>
                  </c:pt>
                  <c:pt idx="3">
                    <c:v>0.0827448316861483</c:v>
                  </c:pt>
                </c:numCache>
              </c:numRef>
            </c:minus>
          </c:errBars>
          <c:cat>
            <c:strRef>
              <c:f>NewCharts_26Jun2015!$O$30:$O$33</c:f>
              <c:strCache>
                <c:ptCount val="4"/>
                <c:pt idx="0">
                  <c:v>MB010B</c:v>
                </c:pt>
                <c:pt idx="1">
                  <c:v>MB152B</c:v>
                </c:pt>
                <c:pt idx="2">
                  <c:v>MB364B</c:v>
                </c:pt>
                <c:pt idx="3">
                  <c:v>MB417B</c:v>
                </c:pt>
              </c:strCache>
            </c:strRef>
          </c:cat>
          <c:val>
            <c:numRef>
              <c:f>NewCharts_26Jun2015!$Q$30:$Q$33</c:f>
              <c:numCache>
                <c:formatCode>General</c:formatCode>
                <c:ptCount val="4"/>
                <c:pt idx="0">
                  <c:v>-0.0759979365079365</c:v>
                </c:pt>
                <c:pt idx="1">
                  <c:v>-0.0417334027777778</c:v>
                </c:pt>
                <c:pt idx="2">
                  <c:v>-0.0925014583333334</c:v>
                </c:pt>
                <c:pt idx="3">
                  <c:v>-0.2192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7147544"/>
        <c:axId val="-2124263832"/>
      </c:barChart>
      <c:catAx>
        <c:axId val="-2117147544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24263832"/>
        <c:crosses val="autoZero"/>
        <c:auto val="1"/>
        <c:lblAlgn val="ctr"/>
        <c:lblOffset val="100"/>
        <c:noMultiLvlLbl val="0"/>
      </c:catAx>
      <c:valAx>
        <c:axId val="-2124263832"/>
        <c:scaling>
          <c:orientation val="minMax"/>
          <c:min val="-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714754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08142808311217"/>
          <c:y val="0.0731625822358946"/>
          <c:w val="0.386506509372064"/>
          <c:h val="0.687594887570692"/>
        </c:manualLayout>
      </c:layout>
      <c:barChart>
        <c:barDir val="col"/>
        <c:grouping val="clustered"/>
        <c:varyColors val="0"/>
        <c:ser>
          <c:idx val="0"/>
          <c:order val="0"/>
          <c:tx>
            <c:v>LI</c:v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SecondaryCharts_22May15!$S$10:$S$11</c:f>
                <c:numCache>
                  <c:formatCode>General</c:formatCode>
                  <c:ptCount val="2"/>
                  <c:pt idx="0">
                    <c:v>0.0112415421484674</c:v>
                  </c:pt>
                  <c:pt idx="1">
                    <c:v>0.004009307394993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econdaryCharts_22May15!$O$10:$O$11</c:f>
              <c:strCache>
                <c:ptCount val="2"/>
                <c:pt idx="0">
                  <c:v>MB005B</c:v>
                </c:pt>
                <c:pt idx="1">
                  <c:v>MB461B</c:v>
                </c:pt>
              </c:strCache>
            </c:strRef>
          </c:cat>
          <c:val>
            <c:numRef>
              <c:f>NewSecondaryCharts_22May15!$P$10:$P$11</c:f>
              <c:numCache>
                <c:formatCode>General</c:formatCode>
                <c:ptCount val="2"/>
                <c:pt idx="0">
                  <c:v>0.0233425490196078</c:v>
                </c:pt>
                <c:pt idx="1">
                  <c:v>0.01358</c:v>
                </c:pt>
              </c:numCache>
            </c:numRef>
          </c:val>
        </c:ser>
        <c:ser>
          <c:idx val="1"/>
          <c:order val="1"/>
          <c:tx>
            <c:v>MI</c:v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NewSecondaryCharts_22May15!$T$10:$T$11</c:f>
                <c:numCache>
                  <c:formatCode>General</c:formatCode>
                  <c:ptCount val="2"/>
                  <c:pt idx="0">
                    <c:v>0.0499574331288847</c:v>
                  </c:pt>
                  <c:pt idx="1">
                    <c:v>0.0708886314939653</c:v>
                  </c:pt>
                </c:numCache>
              </c:numRef>
            </c:minus>
          </c:errBars>
          <c:cat>
            <c:strRef>
              <c:f>NewSecondaryCharts_22May15!$O$10:$O$11</c:f>
              <c:strCache>
                <c:ptCount val="2"/>
                <c:pt idx="0">
                  <c:v>MB005B</c:v>
                </c:pt>
                <c:pt idx="1">
                  <c:v>MB461B</c:v>
                </c:pt>
              </c:strCache>
            </c:strRef>
          </c:cat>
          <c:val>
            <c:numRef>
              <c:f>NewSecondaryCharts_22May15!$Q$10:$Q$11</c:f>
              <c:numCache>
                <c:formatCode>General</c:formatCode>
                <c:ptCount val="2"/>
                <c:pt idx="0">
                  <c:v>-0.141172941176471</c:v>
                </c:pt>
                <c:pt idx="1">
                  <c:v>-0.2285519047619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9223672"/>
        <c:axId val="-2122312408"/>
      </c:barChart>
      <c:catAx>
        <c:axId val="-2119223672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22312408"/>
        <c:crosses val="autoZero"/>
        <c:auto val="1"/>
        <c:lblAlgn val="ctr"/>
        <c:lblOffset val="100"/>
        <c:noMultiLvlLbl val="0"/>
      </c:catAx>
      <c:valAx>
        <c:axId val="-2122312408"/>
        <c:scaling>
          <c:orientation val="minMax"/>
          <c:max val="0.5"/>
          <c:min val="-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922367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340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811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2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33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331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87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980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08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06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363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459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oleObject" Target="../embeddings/oleObject1.bin"/><Relationship Id="rId5" Type="http://schemas.openxmlformats.org/officeDocument/2006/relationships/package" Target="../embeddings/Microsoft_Excel_Sheet1.xlsx"/><Relationship Id="rId6" Type="http://schemas.openxmlformats.org/officeDocument/2006/relationships/image" Target="../media/image1.png"/><Relationship Id="rId7" Type="http://schemas.openxmlformats.org/officeDocument/2006/relationships/chart" Target="../charts/chart2.xml"/><Relationship Id="rId8" Type="http://schemas.openxmlformats.org/officeDocument/2006/relationships/package" Target="../embeddings/Microsoft_Excel_Sheet2.xlsx"/><Relationship Id="rId9" Type="http://schemas.openxmlformats.org/officeDocument/2006/relationships/image" Target="../media/image2.png"/><Relationship Id="rId10" Type="http://schemas.openxmlformats.org/officeDocument/2006/relationships/chart" Target="../charts/chart3.xml"/><Relationship Id="rId11" Type="http://schemas.openxmlformats.org/officeDocument/2006/relationships/chart" Target="../charts/chart4.xml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8628" y="163037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igure S2</a:t>
            </a:r>
            <a:endParaRPr lang="en-US" dirty="0">
              <a:latin typeface="Arial"/>
              <a:cs typeface="Arial"/>
            </a:endParaRPr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8711528"/>
              </p:ext>
            </p:extLst>
          </p:nvPr>
        </p:nvGraphicFramePr>
        <p:xfrm>
          <a:off x="659161" y="757001"/>
          <a:ext cx="2369302" cy="22517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236745" y="662219"/>
            <a:ext cx="1223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/>
                <a:cs typeface="Arial"/>
              </a:rPr>
              <a:t>γ</a:t>
            </a:r>
            <a:r>
              <a:rPr lang="en-US" sz="1200" dirty="0" smtClean="0">
                <a:latin typeface="Arial"/>
                <a:cs typeface="Arial"/>
              </a:rPr>
              <a:t> Kenyon Cell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598987" y="1111652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974605" y="1289972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6425518"/>
              </p:ext>
            </p:extLst>
          </p:nvPr>
        </p:nvGraphicFramePr>
        <p:xfrm>
          <a:off x="1271126" y="3032521"/>
          <a:ext cx="1142169" cy="4469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" name="Worksheet" r:id="rId5" imgW="1117600" imgH="342900" progId="Excel.Sheet.12">
                  <p:embed/>
                </p:oleObj>
              </mc:Choice>
              <mc:Fallback>
                <p:oleObj name="Worksheet" r:id="rId5" imgW="1117600" imgH="3429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71126" y="3032521"/>
                        <a:ext cx="1142169" cy="4469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950887" y="3020650"/>
            <a:ext cx="3201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/>
                <a:cs typeface="Arial"/>
              </a:rPr>
              <a:t>γd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49045" y="3250810"/>
            <a:ext cx="526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/>
                <a:cs typeface="Arial"/>
              </a:rPr>
              <a:t>γmain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08566" y="454599"/>
            <a:ext cx="4677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/>
                <a:cs typeface="Arial"/>
              </a:rPr>
              <a:t>A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30086" y="454599"/>
            <a:ext cx="4677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/>
                <a:cs typeface="Arial"/>
              </a:rPr>
              <a:t>B</a:t>
            </a:r>
          </a:p>
        </p:txBody>
      </p: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561067"/>
              </p:ext>
            </p:extLst>
          </p:nvPr>
        </p:nvGraphicFramePr>
        <p:xfrm>
          <a:off x="3641766" y="757001"/>
          <a:ext cx="2310312" cy="22517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0275896"/>
              </p:ext>
            </p:extLst>
          </p:nvPr>
        </p:nvGraphicFramePr>
        <p:xfrm>
          <a:off x="4246941" y="3032521"/>
          <a:ext cx="1119509" cy="4469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Worksheet" r:id="rId8" imgW="1117600" imgH="749300" progId="Excel.Sheet.12">
                  <p:embed/>
                </p:oleObj>
              </mc:Choice>
              <mc:Fallback>
                <p:oleObj name="Worksheet" r:id="rId8" imgW="1117600" imgH="7493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246941" y="3032521"/>
                        <a:ext cx="1119509" cy="4469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3944310" y="3015505"/>
            <a:ext cx="3201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/>
                <a:cs typeface="Arial"/>
              </a:rPr>
              <a:t>γd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742469" y="3245665"/>
            <a:ext cx="526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/>
                <a:cs typeface="Arial"/>
              </a:rPr>
              <a:t>γmain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199728" y="1296318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303253" y="2183090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673066" y="2188994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036045" y="2315474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930429" y="878094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185608" y="488257"/>
            <a:ext cx="12239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err="1" smtClean="0">
                <a:latin typeface="Arial"/>
                <a:cs typeface="Arial"/>
              </a:rPr>
              <a:t>γ</a:t>
            </a:r>
            <a:r>
              <a:rPr lang="en-US" sz="1200" dirty="0" smtClean="0">
                <a:latin typeface="Arial"/>
                <a:cs typeface="Arial"/>
              </a:rPr>
              <a:t> Kenyon Cells</a:t>
            </a:r>
          </a:p>
          <a:p>
            <a:pPr algn="ctr"/>
            <a:r>
              <a:rPr lang="en-US" sz="1200" dirty="0" smtClean="0">
                <a:latin typeface="Arial"/>
                <a:cs typeface="Arial"/>
              </a:rPr>
              <a:t>Secondary</a:t>
            </a:r>
            <a:endParaRPr lang="en-US" sz="1200" dirty="0">
              <a:latin typeface="Arial"/>
              <a:cs typeface="Arial"/>
            </a:endParaRPr>
          </a:p>
        </p:txBody>
      </p:sp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7258424"/>
              </p:ext>
            </p:extLst>
          </p:nvPr>
        </p:nvGraphicFramePr>
        <p:xfrm>
          <a:off x="3647651" y="4111544"/>
          <a:ext cx="2670955" cy="22512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4" name="TextBox 23"/>
          <p:cNvSpPr txBox="1"/>
          <p:nvPr/>
        </p:nvSpPr>
        <p:spPr>
          <a:xfrm>
            <a:off x="4200695" y="4499268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569095" y="4331988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946135" y="4657188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305895" y="4507188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043491" y="5057011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411891" y="5235331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graphicFrame>
        <p:nvGraphicFramePr>
          <p:cNvPr id="30" name="Table 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9713722"/>
              </p:ext>
            </p:extLst>
          </p:nvPr>
        </p:nvGraphicFramePr>
        <p:xfrm>
          <a:off x="4266596" y="6419263"/>
          <a:ext cx="1468704" cy="1369060"/>
        </p:xfrm>
        <a:graphic>
          <a:graphicData uri="http://schemas.openxmlformats.org/drawingml/2006/table">
            <a:tbl>
              <a:tblPr/>
              <a:tblGrid>
                <a:gridCol w="367176"/>
                <a:gridCol w="367176"/>
                <a:gridCol w="367176"/>
                <a:gridCol w="367176"/>
              </a:tblGrid>
              <a:tr h="1955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</a:tbl>
          </a:graphicData>
        </a:graphic>
      </p:graphicFrame>
      <p:sp>
        <p:nvSpPr>
          <p:cNvPr id="31" name="Rectangle 30"/>
          <p:cNvSpPr/>
          <p:nvPr/>
        </p:nvSpPr>
        <p:spPr>
          <a:xfrm>
            <a:off x="4996685" y="4270821"/>
            <a:ext cx="376083" cy="3517503"/>
          </a:xfrm>
          <a:prstGeom prst="rect">
            <a:avLst/>
          </a:prstGeom>
          <a:noFill/>
          <a:ln w="19050">
            <a:solidFill>
              <a:schemeClr val="accent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5365910" y="4270822"/>
            <a:ext cx="376083" cy="3517503"/>
          </a:xfrm>
          <a:prstGeom prst="rect">
            <a:avLst/>
          </a:prstGeom>
          <a:noFill/>
          <a:ln w="19050">
            <a:solidFill>
              <a:schemeClr val="accent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/>
          <p:cNvSpPr txBox="1"/>
          <p:nvPr/>
        </p:nvSpPr>
        <p:spPr>
          <a:xfrm>
            <a:off x="4224198" y="3979618"/>
            <a:ext cx="15447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Broad Kenyon Cell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420202" y="3713605"/>
            <a:ext cx="4677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/>
                <a:cs typeface="Arial"/>
              </a:rPr>
              <a:t>C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937348" y="6391565"/>
            <a:ext cx="3201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/>
                <a:cs typeface="Arial"/>
              </a:rPr>
              <a:t>γd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735507" y="6583813"/>
            <a:ext cx="526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/>
                <a:cs typeface="Arial"/>
              </a:rPr>
              <a:t>γmain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825480" y="6783603"/>
            <a:ext cx="439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α/βp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816772" y="6983393"/>
            <a:ext cx="4323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α/βs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816772" y="7173705"/>
            <a:ext cx="4323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α/βc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703815" y="7373495"/>
            <a:ext cx="56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α'/β’</a:t>
            </a:r>
            <a:r>
              <a:rPr lang="en-US" sz="1000" dirty="0" err="1" smtClean="0">
                <a:latin typeface="Arial"/>
                <a:cs typeface="Arial"/>
              </a:rPr>
              <a:t>ap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732247" y="7563807"/>
            <a:ext cx="527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α'/β’m</a:t>
            </a:r>
            <a:endParaRPr lang="en-US" sz="1000" dirty="0">
              <a:latin typeface="Arial"/>
              <a:cs typeface="Arial"/>
            </a:endParaRPr>
          </a:p>
        </p:txBody>
      </p:sp>
      <p:graphicFrame>
        <p:nvGraphicFramePr>
          <p:cNvPr id="42" name="Chart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5949189"/>
              </p:ext>
            </p:extLst>
          </p:nvPr>
        </p:nvGraphicFramePr>
        <p:xfrm>
          <a:off x="653279" y="4113505"/>
          <a:ext cx="1998119" cy="22566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43" name="TextBox 42"/>
          <p:cNvSpPr txBox="1"/>
          <p:nvPr/>
        </p:nvSpPr>
        <p:spPr>
          <a:xfrm>
            <a:off x="1332074" y="5323704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716530" y="5487867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218629" y="4849942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602614" y="4881370"/>
            <a:ext cx="372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graphicFrame>
        <p:nvGraphicFramePr>
          <p:cNvPr id="47" name="Table 4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3613963"/>
              </p:ext>
            </p:extLst>
          </p:nvPr>
        </p:nvGraphicFramePr>
        <p:xfrm>
          <a:off x="1276571" y="6422495"/>
          <a:ext cx="764668" cy="391160"/>
        </p:xfrm>
        <a:graphic>
          <a:graphicData uri="http://schemas.openxmlformats.org/drawingml/2006/table">
            <a:tbl>
              <a:tblPr/>
              <a:tblGrid>
                <a:gridCol w="382334"/>
                <a:gridCol w="382334"/>
              </a:tblGrid>
              <a:tr h="1955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</a:tbl>
          </a:graphicData>
        </a:graphic>
      </p:graphicFrame>
      <p:sp>
        <p:nvSpPr>
          <p:cNvPr id="48" name="TextBox 47"/>
          <p:cNvSpPr txBox="1"/>
          <p:nvPr/>
        </p:nvSpPr>
        <p:spPr>
          <a:xfrm>
            <a:off x="724730" y="6396338"/>
            <a:ext cx="56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α'/β’</a:t>
            </a:r>
            <a:r>
              <a:rPr lang="en-US" sz="1000" dirty="0" err="1" smtClean="0">
                <a:latin typeface="Arial"/>
                <a:cs typeface="Arial"/>
              </a:rPr>
              <a:t>ap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753162" y="6586650"/>
            <a:ext cx="527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α'/β’m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136058" y="3788000"/>
            <a:ext cx="14170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α’/β’ Kenyon Cells</a:t>
            </a:r>
          </a:p>
          <a:p>
            <a:pPr algn="ctr"/>
            <a:r>
              <a:rPr lang="en-US" sz="1200" dirty="0" smtClean="0">
                <a:latin typeface="Arial"/>
                <a:cs typeface="Arial"/>
              </a:rPr>
              <a:t>Secondary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532318" y="3713743"/>
            <a:ext cx="4677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/>
                <a:cs typeface="Arial"/>
              </a:rPr>
              <a:t>D</a:t>
            </a:r>
          </a:p>
        </p:txBody>
      </p:sp>
      <p:sp>
        <p:nvSpPr>
          <p:cNvPr id="52" name="Rectangle 51"/>
          <p:cNvSpPr/>
          <p:nvPr/>
        </p:nvSpPr>
        <p:spPr>
          <a:xfrm>
            <a:off x="4253260" y="927883"/>
            <a:ext cx="376083" cy="2540275"/>
          </a:xfrm>
          <a:prstGeom prst="rect">
            <a:avLst/>
          </a:prstGeom>
          <a:noFill/>
          <a:ln w="19050">
            <a:solidFill>
              <a:schemeClr val="accent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2428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3</Words>
  <Application>Microsoft Macintosh PowerPoint</Application>
  <PresentationFormat>Letter Paper (8.5x11 in)</PresentationFormat>
  <Paragraphs>77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Office Theme</vt:lpstr>
      <vt:lpstr>Worksheet</vt:lpstr>
      <vt:lpstr>Microsoft Excel Sheet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lby Montague</dc:creator>
  <cp:lastModifiedBy>Shelby Montague</cp:lastModifiedBy>
  <cp:revision>1</cp:revision>
  <dcterms:created xsi:type="dcterms:W3CDTF">2016-09-29T23:23:19Z</dcterms:created>
  <dcterms:modified xsi:type="dcterms:W3CDTF">2016-09-29T23:23:47Z</dcterms:modified>
</cp:coreProperties>
</file>